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0058400" cy="5741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4884" autoAdjust="0"/>
  </p:normalViewPr>
  <p:slideViewPr>
    <p:cSldViewPr snapToGrid="0">
      <p:cViewPr varScale="1">
        <p:scale>
          <a:sx n="87" d="100"/>
          <a:sy n="87" d="100"/>
        </p:scale>
        <p:origin x="1066" y="58"/>
      </p:cViewPr>
      <p:guideLst>
        <p:guide orient="horz" pos="180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7890ED-11B8-4800-B8B2-72C7F4E99478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25488" y="1143000"/>
            <a:ext cx="5407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7101A8-4275-45CB-8E2F-D2818FB70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68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72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939720"/>
            <a:ext cx="7543800" cy="1999062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015873"/>
            <a:ext cx="7543800" cy="1386318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13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47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305708"/>
            <a:ext cx="2168843" cy="48660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05708"/>
            <a:ext cx="6380798" cy="486606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95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431510"/>
            <a:ext cx="8675370" cy="2388507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842614"/>
            <a:ext cx="8675370" cy="1256059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61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3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05708"/>
            <a:ext cx="8675370" cy="11098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407585"/>
            <a:ext cx="4255174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097421"/>
            <a:ext cx="4255174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407585"/>
            <a:ext cx="4276130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2097421"/>
            <a:ext cx="4276130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73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0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54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826740"/>
            <a:ext cx="5092065" cy="4080533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86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826740"/>
            <a:ext cx="5092065" cy="4080533"/>
          </a:xfrm>
        </p:spPr>
        <p:txBody>
          <a:bodyPr anchor="t"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4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05708"/>
            <a:ext cx="8675370" cy="11098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528538"/>
            <a:ext cx="8675370" cy="3643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559BE-96A6-4C40-8576-E268AFCD6E85}" type="datetimeFigureOut">
              <a:rPr lang="en-US" smtClean="0"/>
              <a:t>3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5321972"/>
            <a:ext cx="339471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6104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4380" rtl="0" eaLnBrk="1" latinLnBrk="0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8262" y="45028"/>
            <a:ext cx="990013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2800" b="1" kern="2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 interpretable radiomics model based on contrast</a:t>
            </a:r>
            <a:r>
              <a:rPr lang="zh-CN" altLang="zh-CN" sz="2800" b="1" kern="2200" dirty="0"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MS Gothic" panose="020B0609070205080204" pitchFamily="49" charset="-128"/>
              </a:rPr>
              <a:t>‑</a:t>
            </a:r>
            <a:r>
              <a:rPr lang="en-US" altLang="zh-CN" sz="2800" b="1" kern="2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hanced </a:t>
            </a:r>
            <a:r>
              <a:rPr lang="en-US" altLang="zh-CN" sz="2800" b="1" kern="2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ncreatic </a:t>
            </a:r>
            <a:r>
              <a:rPr lang="en-US" altLang="zh-CN" sz="2800" b="1" kern="2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uted tomography for predicting the prognosis of post-acute pancreatitis diabetes mellitus</a:t>
            </a:r>
            <a:endParaRPr lang="zh-CN" altLang="zh-CN" sz="2800" b="1" kern="2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443419" y="1976554"/>
            <a:ext cx="417202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24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CECT-based radiomics model performed well in predicting PPDM-A prognosis. SHAP enhances understanding of the model's predictive process, boosting its credibility.</a:t>
            </a:r>
            <a:endParaRPr lang="en-US" sz="2400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1A94352-6888-4CE8-BBDE-C41A4829375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955" y="1553745"/>
            <a:ext cx="4520381" cy="163303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94FE354-F05F-E0BA-06D0-56F3714AC0D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955" y="3215461"/>
            <a:ext cx="4515906" cy="2038841"/>
          </a:xfrm>
          <a:prstGeom prst="rect">
            <a:avLst/>
          </a:prstGeom>
        </p:spPr>
      </p:pic>
      <p:sp>
        <p:nvSpPr>
          <p:cNvPr id="9" name="TextBox 9">
            <a:extLst>
              <a:ext uri="{FF2B5EF4-FFF2-40B4-BE49-F238E27FC236}">
                <a16:creationId xmlns:a16="http://schemas.microsoft.com/office/drawing/2014/main" id="{55B77418-F186-C82F-3FDE-FE2E30B38224}"/>
              </a:ext>
            </a:extLst>
          </p:cNvPr>
          <p:cNvSpPr txBox="1"/>
          <p:nvPr/>
        </p:nvSpPr>
        <p:spPr>
          <a:xfrm>
            <a:off x="377506" y="5372656"/>
            <a:ext cx="18874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effectLst/>
                <a:ea typeface="等线" panose="02010600030101010101" pitchFamily="2" charset="-122"/>
              </a:rPr>
              <a:t>Ran Hu</a:t>
            </a:r>
            <a:r>
              <a:rPr lang="zh-CN" altLang="en-US" baseline="30000" dirty="0">
                <a:effectLst/>
                <a:ea typeface="等线" panose="02010600030101010101" pitchFamily="2" charset="-122"/>
              </a:rPr>
              <a:t> </a:t>
            </a:r>
            <a:r>
              <a:rPr lang="en-US" dirty="0"/>
              <a:t>et al; 2025</a:t>
            </a:r>
          </a:p>
        </p:txBody>
      </p:sp>
    </p:spTree>
    <p:extLst>
      <p:ext uri="{BB962C8B-B14F-4D97-AF65-F5344CB8AC3E}">
        <p14:creationId xmlns:p14="http://schemas.microsoft.com/office/powerpoint/2010/main" val="198629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54</Words>
  <Application>Microsoft Office PowerPoint</Application>
  <PresentationFormat>自定义</PresentationFormat>
  <Paragraphs>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ok,Olga R. (HMFP - Radiology)</dc:creator>
  <cp:lastModifiedBy>13649054028@163.com</cp:lastModifiedBy>
  <cp:revision>17</cp:revision>
  <dcterms:created xsi:type="dcterms:W3CDTF">2020-06-22T01:49:04Z</dcterms:created>
  <dcterms:modified xsi:type="dcterms:W3CDTF">2026-03-03T14:36:26Z</dcterms:modified>
</cp:coreProperties>
</file>